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0E570-773B-4073-938E-42CD020F91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95B6E-EC37-4F10-8F94-B8B762A559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143C1-4338-4012-B81E-28F97FBF52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1775D-9998-44D9-B611-6CBEE074FA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BC593-F63A-47C0-960F-3D9B07CC99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2C1C6-0CAD-42BF-A4C3-508D9057C1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6084D-BCBD-438E-B266-945224A072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608E6-13AE-4109-81AA-D9AB273C04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637D3-C679-4EB9-927A-1ACEF8F8F3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2F453-8C3B-447C-AEDE-098EE6CD98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EFF10-A8B2-4F12-84ED-2C6C5AFECB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08E815-AF4A-45F6-B8CC-E9AAF560FC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5936D5F5-84D5-44DE-8C1A-B50F60D8035B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jet 21" descr=""/>
          <p:cNvPicPr/>
          <p:nvPr/>
        </p:nvPicPr>
        <p:blipFill>
          <a:blip r:embed="rId1"/>
          <a:srcRect l="-1894" t="7045" r="0" b="-81"/>
          <a:stretch/>
        </p:blipFill>
        <p:spPr>
          <a:xfrm>
            <a:off x="2193840" y="851040"/>
            <a:ext cx="5670720" cy="257796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3"/>
          <p:cNvSpPr/>
          <p:nvPr/>
        </p:nvSpPr>
        <p:spPr>
          <a:xfrm>
            <a:off x="3492360" y="681120"/>
            <a:ext cx="62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2640" rIns="62640" tIns="31320" bIns="31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ZoneTexte 4"/>
          <p:cNvSpPr/>
          <p:nvPr/>
        </p:nvSpPr>
        <p:spPr>
          <a:xfrm>
            <a:off x="4500720" y="681120"/>
            <a:ext cx="77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2640" rIns="62640" tIns="31320" bIns="31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ZoneTexte 5"/>
          <p:cNvSpPr/>
          <p:nvPr/>
        </p:nvSpPr>
        <p:spPr>
          <a:xfrm>
            <a:off x="5689440" y="681120"/>
            <a:ext cx="75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2640" rIns="62640" tIns="31320" bIns="31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M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6"/>
          <p:cNvSpPr/>
          <p:nvPr/>
        </p:nvSpPr>
        <p:spPr>
          <a:xfrm>
            <a:off x="7013520" y="681120"/>
            <a:ext cx="62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2640" rIns="62640" tIns="31320" bIns="3132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"/>
          <p:cNvSpPr/>
          <p:nvPr/>
        </p:nvSpPr>
        <p:spPr>
          <a:xfrm>
            <a:off x="184320" y="3863880"/>
            <a:ext cx="8823240" cy="273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2640" rIns="62640" tIns="31320" bIns="313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Figure S1. Validation of transcriptome data by RT-PCR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= Uninoculated root, NOD= Nodule, NMR=Non mycorrhized root and MR= mycorrhized root 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i="1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ZF1</a:t>
            </a: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</a:t>
            </a:r>
            <a:r>
              <a:rPr b="0" i="1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suarina glauca Zinc Finger 1, CgUBI </a:t>
            </a: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</a:t>
            </a:r>
            <a:r>
              <a:rPr b="0" i="1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suarina glauca</a:t>
            </a: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i="1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biquitin</a:t>
            </a:r>
            <a:r>
              <a:rPr b="0" lang="fr-F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Control)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data from microarray of CgZF1 were confirmed by semi-quantitative RT-PCR. The expression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UBI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s constitutive and standardizes the expression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gZF1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br>
              <a:rPr sz="1600"/>
            </a:br>
            <a:br>
              <a:rPr sz="1600"/>
            </a:br>
            <a:br>
              <a:rPr sz="1600"/>
            </a:b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09T11:42:27Z</dcterms:created>
  <dc:creator>diedhiou</dc:creator>
  <dc:description/>
  <dc:language>en-US</dc:language>
  <cp:lastModifiedBy>diedhiou</cp:lastModifiedBy>
  <dcterms:modified xsi:type="dcterms:W3CDTF">2014-07-25T13:09:18Z</dcterms:modified>
  <cp:revision>2</cp:revision>
  <dc:subject/>
  <dc:title>Diapositive 1</dc:title>
</cp:coreProperties>
</file>